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ct" ContentType="image/x-pict"/>
  <Override PartName="/ppt/media/image2.pct" ContentType="image/x-pict"/>
  <Override PartName="/ppt/media/image3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FF9CDF-DBA3-40EA-A695-8E5BCD42948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7A5DAE-1743-4679-AE7F-200BAA88AE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1A9501-54ED-4691-99BD-F0C6FC45FB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066003-37D2-438B-8615-5A9F31CE970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2D26EA-88FF-4440-B0F1-5DFFB67CC4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48162D-B60C-4CEB-B477-DB0A018E90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535C6F-BE08-45EE-AF61-A96A867CFB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1A16EB-6C84-4107-B375-185A8F1B29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850DF-6734-4FF9-B2C4-0E8674C187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DAE2A4-4ACB-43FC-B23A-B094BB329D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26C1FB-C210-4C84-BC3A-1D9B267111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2A2B35-A269-429C-9959-035F422F1A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11935F-BB06-4F1B-9D64-5312EFBE088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ct"/><Relationship Id="rId2" Type="http://schemas.openxmlformats.org/officeDocument/2006/relationships/image" Target="../media/image2.pct"/><Relationship Id="rId3" Type="http://schemas.openxmlformats.org/officeDocument/2006/relationships/image" Target="../media/image3.pct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flipH="1">
            <a:off x="7904880" y="-1500120"/>
            <a:ext cx="400320" cy="54360"/>
          </a:xfrm>
          <a:prstGeom prst="line">
            <a:avLst/>
          </a:prstGeom>
          <a:ln w="57240">
            <a:solidFill>
              <a:srgbClr val="00ff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7560" bIns="75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 flipH="1" flipV="1">
            <a:off x="6884640" y="-1595880"/>
            <a:ext cx="72000" cy="243000"/>
          </a:xfrm>
          <a:prstGeom prst="line">
            <a:avLst/>
          </a:prstGeom>
          <a:ln w="57240">
            <a:solidFill>
              <a:srgbClr val="00ff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074600" y="4038480"/>
            <a:ext cx="449964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Supplemental figure 1.  Kidneys with or without abscess are shown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Abscess is observed as white nodule(s) on red kidney.  For abscess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H and E staining of section is shown. Kidney with abscess was deh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drated through graduated ethanol (70, 95 then 100%) and transferr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into xylenes in order to mount in a paraffin block.  Eight um thicknes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of paraffin sections were deparafinized through graduated ethanol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(100, 95, then 70%) and stained.  Microphotograph was captured by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a digital camera operated by Open lab software through Niko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Exlips 800 (x10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010600" y="2119320"/>
            <a:ext cx="85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Osaka"/>
              </a:rPr>
              <a:t>Absces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839040" y="2133720"/>
            <a:ext cx="1114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Osaka"/>
              </a:rPr>
              <a:t>No absces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"/>
          <p:cNvGrpSpPr/>
          <p:nvPr/>
        </p:nvGrpSpPr>
        <p:grpSpPr>
          <a:xfrm>
            <a:off x="1295280" y="2514600"/>
            <a:ext cx="3657240" cy="1473120"/>
            <a:chOff x="1295280" y="2514600"/>
            <a:chExt cx="3657240" cy="1473120"/>
          </a:xfrm>
        </p:grpSpPr>
        <p:pic>
          <p:nvPicPr>
            <p:cNvPr id="47" name="" descr=""/>
            <p:cNvPicPr/>
            <p:nvPr/>
          </p:nvPicPr>
          <p:blipFill>
            <a:blip r:embed="rId1"/>
            <a:stretch/>
          </p:blipFill>
          <p:spPr>
            <a:xfrm>
              <a:off x="2316960" y="2538720"/>
              <a:ext cx="1189800" cy="1282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" descr=""/>
            <p:cNvPicPr/>
            <p:nvPr/>
          </p:nvPicPr>
          <p:blipFill>
            <a:blip r:embed="rId2"/>
            <a:stretch/>
          </p:blipFill>
          <p:spPr>
            <a:xfrm>
              <a:off x="4032720" y="2514600"/>
              <a:ext cx="919800" cy="13680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9" name=""/>
            <p:cNvGrpSpPr/>
            <p:nvPr/>
          </p:nvGrpSpPr>
          <p:grpSpPr>
            <a:xfrm>
              <a:off x="1295280" y="2530800"/>
              <a:ext cx="884880" cy="1368000"/>
              <a:chOff x="1295280" y="2530800"/>
              <a:chExt cx="884880" cy="1368000"/>
            </a:xfrm>
          </p:grpSpPr>
          <p:pic>
            <p:nvPicPr>
              <p:cNvPr id="50" name="" descr=""/>
              <p:cNvPicPr/>
              <p:nvPr/>
            </p:nvPicPr>
            <p:blipFill>
              <a:blip r:embed="rId3"/>
              <a:stretch/>
            </p:blipFill>
            <p:spPr>
              <a:xfrm>
                <a:off x="1295280" y="2530800"/>
                <a:ext cx="884880" cy="1368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1" name=""/>
              <p:cNvSpPr/>
              <p:nvPr/>
            </p:nvSpPr>
            <p:spPr>
              <a:xfrm>
                <a:off x="1315080" y="2727720"/>
                <a:ext cx="444240" cy="192240"/>
              </a:xfrm>
              <a:prstGeom prst="line">
                <a:avLst/>
              </a:prstGeom>
              <a:ln w="57240">
                <a:solidFill>
                  <a:srgbClr val="00ff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2" name=""/>
            <p:cNvSpPr/>
            <p:nvPr/>
          </p:nvSpPr>
          <p:spPr>
            <a:xfrm>
              <a:off x="2597400" y="2538000"/>
              <a:ext cx="118440" cy="267120"/>
            </a:xfrm>
            <a:prstGeom prst="line">
              <a:avLst/>
            </a:prstGeom>
            <a:ln w="57240">
              <a:solidFill>
                <a:srgbClr val="00ff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flipH="1">
              <a:off x="3058200" y="2623320"/>
              <a:ext cx="178920" cy="232200"/>
            </a:xfrm>
            <a:prstGeom prst="line">
              <a:avLst/>
            </a:prstGeom>
            <a:ln w="57240">
              <a:solidFill>
                <a:srgbClr val="00ff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flipH="1">
              <a:off x="3355200" y="2756880"/>
              <a:ext cx="178920" cy="232200"/>
            </a:xfrm>
            <a:prstGeom prst="line">
              <a:avLst/>
            </a:prstGeom>
            <a:ln w="57240">
              <a:solidFill>
                <a:srgbClr val="00ff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flipH="1" flipV="1">
              <a:off x="2940480" y="3694680"/>
              <a:ext cx="151200" cy="250200"/>
            </a:xfrm>
            <a:prstGeom prst="line">
              <a:avLst/>
            </a:prstGeom>
            <a:ln w="57240">
              <a:solidFill>
                <a:srgbClr val="00ff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flipV="1">
              <a:off x="2624400" y="3705840"/>
              <a:ext cx="81360" cy="281880"/>
            </a:xfrm>
            <a:prstGeom prst="line">
              <a:avLst/>
            </a:prstGeom>
            <a:ln w="57240">
              <a:solidFill>
                <a:srgbClr val="00ff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4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11T14:37:45Z</dcterms:created>
  <dc:creator>k t</dc:creator>
  <dc:description/>
  <dc:language>en-US</dc:language>
  <cp:lastModifiedBy>k/takahashi</cp:lastModifiedBy>
  <cp:lastPrinted>2012-05-05T00:20:34Z</cp:lastPrinted>
  <dcterms:modified xsi:type="dcterms:W3CDTF">2013-06-25T10:22:28Z</dcterms:modified>
  <cp:revision>568</cp:revision>
  <dc:subject/>
  <dc:title>PowerPoint Presentation</dc:title>
</cp:coreProperties>
</file>